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A7C9B1-3087-445A-9F7A-0EA7AB95B6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9BB4E1-3B23-4F5F-9A1D-69759FA12B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64D93-AFEB-46F1-BE47-228744256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83C3ED-9E60-4F38-8AC1-55BFD9255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04E6D-02C0-4373-8B54-A23D3F267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583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B14217-5CAD-47D4-BA10-C79D77BEA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6AF731-C675-43D5-A212-9BED583F6D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C12905-B563-43E3-95A0-07AB3F6FF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D4DD79-AEB6-4070-A0AE-AAA6D8FC4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F6A41-BCD7-44BF-A951-A1677D0D3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289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7D5E76-9AAE-4900-BC6C-88750AFE29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758FD3-F84D-46C4-8FFD-393EAFEC88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4EC5E5-3C04-4AD0-9808-D43B5DCA3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22B730-5FDC-429F-91F8-A27D1AD2A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2D9E59-BD57-4853-B0E9-56C58DE0D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533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EC71A-D9EC-4763-8F38-DDB0280E3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0C0280-CE28-49C8-B6D2-89A53116E8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2C096F-16F0-401E-BDC8-051E6F1D4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90E37C-0058-4528-82F5-B8B4A6310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10BE34-45CF-4110-B6A8-1D3B19ED1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780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E4055-B949-4C19-9724-5ADAF1F67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EF43AB-D542-446E-B93F-5676474ACD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38E9C9-7EEF-4EAF-9EA2-4B71C04DD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85D94B-285D-4513-9E39-0F21F0292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638438-A59D-4829-BEFE-69DB39D29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61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1082D9-E61D-4964-9AE6-997586B9C8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05E3B7-2100-4D15-A163-CE4C019DBF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D543E7-8607-4782-B93B-576D2D453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1E9C5E-D2AB-4AB0-B6E0-0FCCA005A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E6C43-0C0D-4632-B5A1-5916980E8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41C3C1-43A5-4456-88AD-5855779ED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531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3DA721-36C7-4B41-941A-3DC1BA3D4A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C03854-A426-437E-9C1E-246F19B3D8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DDC614-F678-4205-AAD8-4FC72A7A22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ECA59D-1550-419A-8700-49837E5D9E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86DC23-B68A-4654-B913-02B4C67029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1DCDE9-45B7-4F66-889D-B4BC1B10F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218C88-BFA3-48FC-9AB3-84C5A5FDE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31C641-0E01-45B3-ACC5-BE5536DD9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346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162E0E-69BC-4CB0-8C41-443CABCC3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AA2E1F-271A-4842-90A5-5563DFDE5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C52D13-1028-46F4-8C3E-3264EBC47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17BF6C-C291-439B-932F-700E3DA9D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136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B8CA238-73B2-486C-9A1B-033F8C68E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0B096E-6243-4486-A609-43759DEC6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4CFFDD-B91B-4EE6-BC66-281636783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12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7A2D17-0DED-43C4-B803-300F39614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5BA1C4-A1E4-416E-8AD0-25DA235254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1D68C1-8DDF-4842-BE6D-DE65D8B3CF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FBD3AD-F46D-4446-8557-EC7FCD480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57257B-1B37-4F6D-BC1D-EA170A534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B31C8C-71D5-486F-BC8A-037E6BEFF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035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06573-9ABD-47CC-8B45-DDE7613FFB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3D0E85-C6AC-4F5A-A580-B966AF1E44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3F8AFD-AC17-4212-B043-D64DE42372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3FA0C4-065C-4D69-B31C-99702E301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BF6D32-0335-49FC-BC84-833451303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C77F5E-41A0-4780-A104-9347BFD48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077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D9B27E-DB76-4641-8F6D-7A6DBE564A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B1735B-B15E-4CC9-A6E7-C543BD11AC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0D57B6-3B4A-4AF1-ACDA-2ED62C19C6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90BBD-DE4F-4649-90C0-711C14A73C81}" type="datetimeFigureOut">
              <a:rPr lang="en-US" smtClean="0"/>
              <a:t>5/25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D7DA76-D4AD-4B63-8FEE-60734476E8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7304C7-9C0D-4F88-9856-21BB36E7EC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767B7-FC9D-4A35-B9C7-7077EF33E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613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5" descr="E:\lijianshao at zhou Lab\information\frineds\Bohai Kuang\Ying Huang-2016\Ying Huang\Fig 2A-HT-29 Tubastain A.tiff">
            <a:extLst>
              <a:ext uri="{FF2B5EF4-FFF2-40B4-BE49-F238E27FC236}">
                <a16:creationId xmlns:a16="http://schemas.microsoft.com/office/drawing/2014/main" id="{19F3FD02-A663-477F-AD63-E2340073AB5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742"/>
          <a:stretch/>
        </p:blipFill>
        <p:spPr bwMode="auto">
          <a:xfrm>
            <a:off x="458788" y="939800"/>
            <a:ext cx="2320925" cy="18508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Picture 20">
            <a:extLst>
              <a:ext uri="{FF2B5EF4-FFF2-40B4-BE49-F238E27FC236}">
                <a16:creationId xmlns:a16="http://schemas.microsoft.com/office/drawing/2014/main" id="{2B9F3C6A-365E-473E-BFAF-38EE2C83CEE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4056"/>
          <a:stretch/>
        </p:blipFill>
        <p:spPr bwMode="auto">
          <a:xfrm>
            <a:off x="2876278" y="944563"/>
            <a:ext cx="2505075" cy="16203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4" name="Picture 6" descr="E:\lijianshao at zhou Lab\information\frineds\Bohai Kuang\Ying Huang-2016\Ying Huang\Fig 2B-HT-29  PCI-34051.tiff">
            <a:extLst>
              <a:ext uri="{FF2B5EF4-FFF2-40B4-BE49-F238E27FC236}">
                <a16:creationId xmlns:a16="http://schemas.microsoft.com/office/drawing/2014/main" id="{408F8CE5-990F-4A2A-970B-26DEBD24FF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988" y="3314700"/>
            <a:ext cx="2344737" cy="2074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5" name="Picture 2" descr="https://attachment.outlook.office.net/owa/qiangshao74@hotmail.com/service.svc/s/GetAttachmentThumbnail?id=AQMkADAwATZiZmYAZC04M2Q3LTM4YzAtMDACLTAwCgBGAAADMnPXpkxKQEAAhJ8OCikDIVoHAFQYYITxGEVCqEVkV73O9DcAAAIBYAAAAEoxrdm%2B%2BfdBo2Hd1PKn%2FksAAAAgQp4EAAAAARIAEAAw7YW1G4ipRZbh4J8LREsu&amp;thumbnailType=2&amp;X-OWA-CANARY=VJXhfiS7GkewNtVJIWTFF8Aq11UvwNQYKQv5G9Xu9ZEhICn8FagwXhVjzKW40uJpuY16G7BLALs.&amp;token=eyJ0eXAiOiJKV1QiLCJhbGciOiJSUzI1NiIsIng1dCI6ImVuaDlCSnJWUFU1aWpWMXFqWmpWLWZMMmJjbyJ9.eyJ2ZXIiOiJFeGNoYW5nZS5DYWxsYmFjay5WMSIsImFwcGN0eHNlbmRlciI6Ik93YURvd25sb2FkQDg0ZGY5ZTdmLWU5ZjYtNDBhZi1iNDM1LWFhYWFhYWFhYWFhYSIsImFwcGN0eCI6IntcIm1zZXhjaHByb3RcIjpcIm93YVwiLFwicHJpbWFyeXNpZFwiOlwiUy0xLTI4MjctNDQyMzY1LTIyMTE5MjAwNjRcIixcInB1aWRcIjpcIjE4OTk5NDU0MTk4MTUxMDRcIixcIm9pZFwiOlwiMDAwNmJmZmQtODNkNy0zOGMwLTAwMDAtMDAwMDAwMDAwMDAwXCIsXCJzY29wZVwiOlwiT3dhRG93bmxvYWRcIn0iLCJpc3MiOiIwMDAwMDAwMi0wMDAwLTBmZjEtY2UwMC0wMDAwMDAwMDAwMDBAODRkZjllN2YtZTlmNi00MGFmLWI0MzUtYWFhYWFhYWFhYWFhIiwiYXVkIjoiMDAwMDAwMDItMDAwMC0wZmYxLWNlMDAtMDAwMDAwMDAwMDAwL2F0dGFjaG1lbnQub3V0bG9vay5vZmZpY2UubmV0QDg0ZGY5ZTdmLWU5ZjYtNDBhZi1iNDM1LWFhYWFhYWFhYWFhYSIsImV4cCI6MTQ5ODg3OTQxMiwibmJmIjoxNDk4ODc4ODEyfQ.AOuzJaVDepGiqcHL-ZM5tiLRx0bvc7ZqKSrCrwGLemH9jnkGxYDX8wqpUUxFwPMggpc20vfQRJsSg8cghB-B-6Wioc0YgE1KfrVb7rJ_vOiTfAUgTEfgTRfGKTNas3A1b8qZ0KpLAcyEOLhpOoCAmBkBpjIacKBfjubNpjRdn2nCn6AkUs_2X_mpklTASad7fUvsAyYxfzaqpD-7q8xHpAyQI1MgsYZ1rUdtdQCUv3zbPL5ODxnn7gVDsWrgJid_viJz9amZIuHX84HwGqWEkKcPNGGbbLGEFoF9BRNX1Xt05GvIWvbGhUK1luLRxHw6R-n-OPfVFh57A4W8hUVjJw&amp;owa=outlook.live.com&amp;isc=1">
            <a:extLst>
              <a:ext uri="{FF2B5EF4-FFF2-40B4-BE49-F238E27FC236}">
                <a16:creationId xmlns:a16="http://schemas.microsoft.com/office/drawing/2014/main" id="{C077DB6F-8041-481E-B6F8-A6F979199DA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943"/>
          <a:stretch/>
        </p:blipFill>
        <p:spPr bwMode="auto">
          <a:xfrm>
            <a:off x="2855640" y="3314701"/>
            <a:ext cx="2501900" cy="16203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6" name="TextBox 16">
            <a:extLst>
              <a:ext uri="{FF2B5EF4-FFF2-40B4-BE49-F238E27FC236}">
                <a16:creationId xmlns:a16="http://schemas.microsoft.com/office/drawing/2014/main" id="{07D5710E-1006-486C-BDDB-DD1B8E8923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5" y="606425"/>
            <a:ext cx="45720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2000" b="1"/>
              <a:t>A</a:t>
            </a:r>
          </a:p>
        </p:txBody>
      </p:sp>
      <p:sp>
        <p:nvSpPr>
          <p:cNvPr id="10247" name="TextBox 16">
            <a:extLst>
              <a:ext uri="{FF2B5EF4-FFF2-40B4-BE49-F238E27FC236}">
                <a16:creationId xmlns:a16="http://schemas.microsoft.com/office/drawing/2014/main" id="{265DD5F4-CCA1-458E-95F4-E21C772B71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25" y="3062288"/>
            <a:ext cx="45720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2000" b="1"/>
              <a:t>B</a:t>
            </a:r>
          </a:p>
        </p:txBody>
      </p:sp>
      <p:sp>
        <p:nvSpPr>
          <p:cNvPr id="10248" name="TextBox 13">
            <a:extLst>
              <a:ext uri="{FF2B5EF4-FFF2-40B4-BE49-F238E27FC236}">
                <a16:creationId xmlns:a16="http://schemas.microsoft.com/office/drawing/2014/main" id="{02BF1089-916B-4AFA-A3CD-E75C37527F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91400" y="4763"/>
            <a:ext cx="4371975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2000" b="1" dirty="0" err="1"/>
              <a:t>Huang_et</a:t>
            </a:r>
            <a:r>
              <a:rPr lang="en-US" altLang="zh-CN" sz="2000" b="1" dirty="0"/>
              <a:t> al. Supplementary Fig. 2</a:t>
            </a:r>
            <a:endParaRPr lang="zh-CN" altLang="en-US" sz="2000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3057139-5865-4477-883A-304C857C9BA8}"/>
              </a:ext>
            </a:extLst>
          </p:cNvPr>
          <p:cNvSpPr txBox="1"/>
          <p:nvPr/>
        </p:nvSpPr>
        <p:spPr>
          <a:xfrm>
            <a:off x="3391560" y="2741884"/>
            <a:ext cx="1776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/>
              <a:t>Tubastatin</a:t>
            </a:r>
            <a:r>
              <a:rPr lang="en-US" sz="1200" b="1" dirty="0"/>
              <a:t> A (log, µM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0CEF259-23A6-49A8-BA75-1D8103B66D66}"/>
              </a:ext>
            </a:extLst>
          </p:cNvPr>
          <p:cNvSpPr txBox="1"/>
          <p:nvPr/>
        </p:nvSpPr>
        <p:spPr>
          <a:xfrm>
            <a:off x="3606045" y="2513652"/>
            <a:ext cx="1228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centration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4F5F4343-DF7A-49CC-ADC8-BCD4053629A9}"/>
              </a:ext>
            </a:extLst>
          </p:cNvPr>
          <p:cNvCxnSpPr/>
          <p:nvPr/>
        </p:nvCxnSpPr>
        <p:spPr>
          <a:xfrm>
            <a:off x="3530870" y="2764147"/>
            <a:ext cx="13298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1CBD152F-D8B5-4253-BD67-513A58F673DD}"/>
              </a:ext>
            </a:extLst>
          </p:cNvPr>
          <p:cNvSpPr txBox="1"/>
          <p:nvPr/>
        </p:nvSpPr>
        <p:spPr>
          <a:xfrm>
            <a:off x="3441273" y="5123896"/>
            <a:ext cx="1598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PCI-34051 (log, µM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4FDDEAC-77A1-48DC-AA06-FF01BBBD6DE0}"/>
              </a:ext>
            </a:extLst>
          </p:cNvPr>
          <p:cNvSpPr txBox="1"/>
          <p:nvPr/>
        </p:nvSpPr>
        <p:spPr>
          <a:xfrm>
            <a:off x="3602750" y="4869160"/>
            <a:ext cx="1228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oncentration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7933BCD-513D-4CB3-A011-5BDF5181704D}"/>
              </a:ext>
            </a:extLst>
          </p:cNvPr>
          <p:cNvCxnSpPr/>
          <p:nvPr/>
        </p:nvCxnSpPr>
        <p:spPr>
          <a:xfrm>
            <a:off x="3525122" y="5132907"/>
            <a:ext cx="13298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3F1BC42A-CF83-4F5E-BCF8-689554AF6583}"/>
              </a:ext>
            </a:extLst>
          </p:cNvPr>
          <p:cNvSpPr/>
          <p:nvPr/>
        </p:nvSpPr>
        <p:spPr>
          <a:xfrm>
            <a:off x="2969469" y="1196752"/>
            <a:ext cx="287288" cy="11008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E0F2FAC-3FEA-4D3B-B8B3-ED427AEB93E9}"/>
              </a:ext>
            </a:extLst>
          </p:cNvPr>
          <p:cNvSpPr/>
          <p:nvPr/>
        </p:nvSpPr>
        <p:spPr>
          <a:xfrm>
            <a:off x="2950469" y="3552260"/>
            <a:ext cx="287288" cy="11008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0C23F1E-02A6-4CF9-A0C1-EB9CD4258156}"/>
              </a:ext>
            </a:extLst>
          </p:cNvPr>
          <p:cNvSpPr txBox="1"/>
          <p:nvPr/>
        </p:nvSpPr>
        <p:spPr>
          <a:xfrm rot="16200000">
            <a:off x="2502753" y="1532469"/>
            <a:ext cx="1276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rvival fractio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1FF3239-8ABE-4A95-A9F9-F142710DCDF6}"/>
              </a:ext>
            </a:extLst>
          </p:cNvPr>
          <p:cNvSpPr txBox="1"/>
          <p:nvPr/>
        </p:nvSpPr>
        <p:spPr>
          <a:xfrm rot="16200000">
            <a:off x="2515317" y="3902985"/>
            <a:ext cx="1276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rvival fractio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05D9729-21EC-4392-8CB1-E660C814495E}"/>
              </a:ext>
            </a:extLst>
          </p:cNvPr>
          <p:cNvSpPr txBox="1"/>
          <p:nvPr/>
        </p:nvSpPr>
        <p:spPr>
          <a:xfrm>
            <a:off x="1186204" y="2735424"/>
            <a:ext cx="14570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+mj-lt"/>
                <a:cs typeface="Times New Roman" panose="02020603050405020304" pitchFamily="18" charset="0"/>
              </a:rPr>
              <a:t>Tubastatin</a:t>
            </a:r>
            <a:r>
              <a:rPr lang="en-US" sz="1200" b="1" dirty="0">
                <a:latin typeface="+mj-lt"/>
                <a:cs typeface="Times New Roman" panose="02020603050405020304" pitchFamily="18" charset="0"/>
              </a:rPr>
              <a:t> A (µM)</a:t>
            </a:r>
            <a:endParaRPr lang="en-US" sz="1100" b="1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2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ang shao</dc:creator>
  <cp:lastModifiedBy>qiang shao</cp:lastModifiedBy>
  <cp:revision>1</cp:revision>
  <dcterms:created xsi:type="dcterms:W3CDTF">2018-05-26T04:07:04Z</dcterms:created>
  <dcterms:modified xsi:type="dcterms:W3CDTF">2018-05-26T04:07:22Z</dcterms:modified>
</cp:coreProperties>
</file>